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1" r:id="rId2"/>
    <p:sldId id="302" r:id="rId3"/>
    <p:sldId id="303" r:id="rId4"/>
    <p:sldId id="304" r:id="rId5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-1695" y="-6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0F928-851B-4CA8-8867-FFCD2E5C3638}" type="datetimeFigureOut">
              <a:rPr lang="ko-KR" altLang="en-US" smtClean="0"/>
              <a:t>2021-10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41011-D378-417D-80DB-3BD405F43C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11104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0F928-851B-4CA8-8867-FFCD2E5C3638}" type="datetimeFigureOut">
              <a:rPr lang="ko-KR" altLang="en-US" smtClean="0"/>
              <a:t>2021-10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41011-D378-417D-80DB-3BD405F43C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1940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0F928-851B-4CA8-8867-FFCD2E5C3638}" type="datetimeFigureOut">
              <a:rPr lang="ko-KR" altLang="en-US" smtClean="0"/>
              <a:t>2021-10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41011-D378-417D-80DB-3BD405F43C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1544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0F928-851B-4CA8-8867-FFCD2E5C3638}" type="datetimeFigureOut">
              <a:rPr lang="ko-KR" altLang="en-US" smtClean="0"/>
              <a:t>2021-10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41011-D378-417D-80DB-3BD405F43C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52873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0F928-851B-4CA8-8867-FFCD2E5C3638}" type="datetimeFigureOut">
              <a:rPr lang="ko-KR" altLang="en-US" smtClean="0"/>
              <a:t>2021-10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41011-D378-417D-80DB-3BD405F43C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1925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0F928-851B-4CA8-8867-FFCD2E5C3638}" type="datetimeFigureOut">
              <a:rPr lang="ko-KR" altLang="en-US" smtClean="0"/>
              <a:t>2021-10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41011-D378-417D-80DB-3BD405F43C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1982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0F928-851B-4CA8-8867-FFCD2E5C3638}" type="datetimeFigureOut">
              <a:rPr lang="ko-KR" altLang="en-US" smtClean="0"/>
              <a:t>2021-10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41011-D378-417D-80DB-3BD405F43C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5709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0F928-851B-4CA8-8867-FFCD2E5C3638}" type="datetimeFigureOut">
              <a:rPr lang="ko-KR" altLang="en-US" smtClean="0"/>
              <a:t>2021-10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41011-D378-417D-80DB-3BD405F43C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9915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0F928-851B-4CA8-8867-FFCD2E5C3638}" type="datetimeFigureOut">
              <a:rPr lang="ko-KR" altLang="en-US" smtClean="0"/>
              <a:t>2021-10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41011-D378-417D-80DB-3BD405F43C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1348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0F928-851B-4CA8-8867-FFCD2E5C3638}" type="datetimeFigureOut">
              <a:rPr lang="ko-KR" altLang="en-US" smtClean="0"/>
              <a:t>2021-10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41011-D378-417D-80DB-3BD405F43C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57673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0F928-851B-4CA8-8867-FFCD2E5C3638}" type="datetimeFigureOut">
              <a:rPr lang="ko-KR" altLang="en-US" smtClean="0"/>
              <a:t>2021-10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41011-D378-417D-80DB-3BD405F43C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6257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50F928-851B-4CA8-8867-FFCD2E5C3638}" type="datetimeFigureOut">
              <a:rPr lang="ko-KR" altLang="en-US" smtClean="0"/>
              <a:t>2021-10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41011-D378-417D-80DB-3BD405F43C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3332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11416" y="61472"/>
            <a:ext cx="40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/>
              <a:t>A</a:t>
            </a:r>
            <a:endParaRPr lang="ko-KR" alt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11416" y="3567952"/>
            <a:ext cx="40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/>
              <a:t>B</a:t>
            </a:r>
            <a:endParaRPr lang="ko-KR" altLang="en-US" b="1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186" y="88366"/>
            <a:ext cx="3404038" cy="30121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668" y="3567952"/>
            <a:ext cx="3488555" cy="30121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0117" y="61472"/>
            <a:ext cx="3404038" cy="30390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0117" y="3567952"/>
            <a:ext cx="3404038" cy="30121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518668" y="2735559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5064274" y="2706573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445447" y="6215179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5064273" y="6207524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</p:spTree>
    <p:extLst>
      <p:ext uri="{BB962C8B-B14F-4D97-AF65-F5344CB8AC3E}">
        <p14:creationId xmlns:p14="http://schemas.microsoft.com/office/powerpoint/2010/main" val="22268055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11416" y="61472"/>
            <a:ext cx="40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/>
              <a:t>C</a:t>
            </a:r>
            <a:endParaRPr lang="ko-KR" alt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11416" y="3567952"/>
            <a:ext cx="40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/>
              <a:t>D</a:t>
            </a:r>
            <a:endParaRPr lang="ko-KR" altLang="en-US" b="1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185" y="88366"/>
            <a:ext cx="3404038" cy="30121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185" y="3567952"/>
            <a:ext cx="3404038" cy="29750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8301" y="61472"/>
            <a:ext cx="3375851" cy="30390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8302" y="3567954"/>
            <a:ext cx="3375851" cy="29750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518668" y="2735559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5064274" y="2706573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533495" y="6167485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5064273" y="6168327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</p:spTree>
    <p:extLst>
      <p:ext uri="{BB962C8B-B14F-4D97-AF65-F5344CB8AC3E}">
        <p14:creationId xmlns:p14="http://schemas.microsoft.com/office/powerpoint/2010/main" val="2546924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11416" y="61472"/>
            <a:ext cx="40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/>
              <a:t>E</a:t>
            </a:r>
            <a:endParaRPr lang="ko-KR" alt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11416" y="3567952"/>
            <a:ext cx="40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/>
              <a:t>F</a:t>
            </a:r>
            <a:endParaRPr lang="ko-KR" altLang="en-US" b="1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185" y="113738"/>
            <a:ext cx="3404038" cy="29867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185" y="3567952"/>
            <a:ext cx="3404038" cy="30121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0117" y="113738"/>
            <a:ext cx="3404037" cy="29867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0117" y="3567952"/>
            <a:ext cx="3404038" cy="30121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518668" y="2735559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064274" y="2706573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533495" y="6167485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5064273" y="6207524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</p:spTree>
    <p:extLst>
      <p:ext uri="{BB962C8B-B14F-4D97-AF65-F5344CB8AC3E}">
        <p14:creationId xmlns:p14="http://schemas.microsoft.com/office/powerpoint/2010/main" val="27880804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11416" y="61472"/>
            <a:ext cx="40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/>
              <a:t>G</a:t>
            </a:r>
            <a:endParaRPr lang="ko-KR" alt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11416" y="3567952"/>
            <a:ext cx="407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/>
              <a:t>H</a:t>
            </a:r>
            <a:endParaRPr lang="ko-KR" altLang="en-US" b="1" dirty="0"/>
          </a:p>
        </p:txBody>
      </p:sp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186" y="115261"/>
            <a:ext cx="3404038" cy="29852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186" y="3567951"/>
            <a:ext cx="3404038" cy="30121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0117" y="115261"/>
            <a:ext cx="3404038" cy="29852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0117" y="3567951"/>
            <a:ext cx="3404038" cy="3012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518668" y="2735559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5064274" y="2706573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533495" y="6167485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5055578" y="6207524"/>
            <a:ext cx="676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No. at risk</a:t>
            </a:r>
            <a:endParaRPr lang="ko-KR" altLang="en-US" sz="800" b="1" dirty="0"/>
          </a:p>
        </p:txBody>
      </p:sp>
    </p:spTree>
    <p:extLst>
      <p:ext uri="{BB962C8B-B14F-4D97-AF65-F5344CB8AC3E}">
        <p14:creationId xmlns:p14="http://schemas.microsoft.com/office/powerpoint/2010/main" val="3954402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61</TotalTime>
  <Words>72</Words>
  <Application>Microsoft Office PowerPoint</Application>
  <PresentationFormat>화면 슬라이드 쇼(4:3)</PresentationFormat>
  <Paragraphs>24</Paragraphs>
  <Slides>4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5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ong Hoon Kim</dc:creator>
  <cp:lastModifiedBy>Windows 사용자</cp:lastModifiedBy>
  <cp:revision>54</cp:revision>
  <dcterms:created xsi:type="dcterms:W3CDTF">2021-08-26T02:31:13Z</dcterms:created>
  <dcterms:modified xsi:type="dcterms:W3CDTF">2021-10-06T14:41:39Z</dcterms:modified>
</cp:coreProperties>
</file>